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2" r:id="rId2"/>
  </p:sldIdLst>
  <p:sldSz cx="6858000" cy="9906000" type="A4"/>
  <p:notesSz cx="9926638" cy="666908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rebs, Franziska" initials="KF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46" autoAdjust="0"/>
    <p:restoredTop sz="92337" autoAdjust="0"/>
  </p:normalViewPr>
  <p:slideViewPr>
    <p:cSldViewPr>
      <p:cViewPr>
        <p:scale>
          <a:sx n="218" d="100"/>
          <a:sy n="218" d="100"/>
        </p:scale>
        <p:origin x="-264" y="352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839" cy="333093"/>
          </a:xfrm>
          <a:prstGeom prst="rect">
            <a:avLst/>
          </a:prstGeom>
        </p:spPr>
        <p:txBody>
          <a:bodyPr vert="horz" lIns="87938" tIns="43969" rIns="87938" bIns="43969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622581" y="0"/>
            <a:ext cx="4301839" cy="333093"/>
          </a:xfrm>
          <a:prstGeom prst="rect">
            <a:avLst/>
          </a:prstGeom>
        </p:spPr>
        <p:txBody>
          <a:bodyPr vert="horz" lIns="87938" tIns="43969" rIns="87938" bIns="43969" rtlCol="0"/>
          <a:lstStyle>
            <a:lvl1pPr algn="r">
              <a:defRPr sz="1200"/>
            </a:lvl1pPr>
          </a:lstStyle>
          <a:p>
            <a:fld id="{34FF59E7-C785-4476-8CF9-DBAC5A24D17E}" type="datetimeFigureOut">
              <a:rPr lang="de-DE" smtClean="0"/>
              <a:t>19.11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6334962"/>
            <a:ext cx="4301839" cy="333093"/>
          </a:xfrm>
          <a:prstGeom prst="rect">
            <a:avLst/>
          </a:prstGeom>
        </p:spPr>
        <p:txBody>
          <a:bodyPr vert="horz" lIns="87938" tIns="43969" rIns="87938" bIns="43969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622581" y="6334962"/>
            <a:ext cx="4301839" cy="333093"/>
          </a:xfrm>
          <a:prstGeom prst="rect">
            <a:avLst/>
          </a:prstGeom>
        </p:spPr>
        <p:txBody>
          <a:bodyPr vert="horz" lIns="87938" tIns="43969" rIns="87938" bIns="43969" rtlCol="0" anchor="b"/>
          <a:lstStyle>
            <a:lvl1pPr algn="r">
              <a:defRPr sz="1200"/>
            </a:lvl1pPr>
          </a:lstStyle>
          <a:p>
            <a:fld id="{CFBCA07A-3A8E-442C-87B9-F11C11F576A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130957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301542" cy="333455"/>
          </a:xfrm>
          <a:prstGeom prst="rect">
            <a:avLst/>
          </a:prstGeom>
        </p:spPr>
        <p:txBody>
          <a:bodyPr vert="horz" lIns="91842" tIns="45921" rIns="91842" bIns="45921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622800" y="0"/>
            <a:ext cx="4301542" cy="333455"/>
          </a:xfrm>
          <a:prstGeom prst="rect">
            <a:avLst/>
          </a:prstGeom>
        </p:spPr>
        <p:txBody>
          <a:bodyPr vert="horz" lIns="91842" tIns="45921" rIns="91842" bIns="45921" rtlCol="0"/>
          <a:lstStyle>
            <a:lvl1pPr algn="r">
              <a:defRPr sz="1300"/>
            </a:lvl1pPr>
          </a:lstStyle>
          <a:p>
            <a:fld id="{61CE6380-E9E1-4DA9-A1E8-3A3756AC5940}" type="datetimeFigureOut">
              <a:rPr lang="de-DE" smtClean="0"/>
              <a:t>19.11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097338" y="501650"/>
            <a:ext cx="1731962" cy="25003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42" tIns="45921" rIns="91842" bIns="45921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92665" y="3167817"/>
            <a:ext cx="7941310" cy="3001090"/>
          </a:xfrm>
          <a:prstGeom prst="rect">
            <a:avLst/>
          </a:prstGeom>
        </p:spPr>
        <p:txBody>
          <a:bodyPr vert="horz" lIns="91842" tIns="45921" rIns="91842" bIns="45921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2" y="6334476"/>
            <a:ext cx="4301542" cy="333455"/>
          </a:xfrm>
          <a:prstGeom prst="rect">
            <a:avLst/>
          </a:prstGeom>
        </p:spPr>
        <p:txBody>
          <a:bodyPr vert="horz" lIns="91842" tIns="45921" rIns="91842" bIns="45921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622800" y="6334476"/>
            <a:ext cx="4301542" cy="333455"/>
          </a:xfrm>
          <a:prstGeom prst="rect">
            <a:avLst/>
          </a:prstGeom>
        </p:spPr>
        <p:txBody>
          <a:bodyPr vert="horz" lIns="91842" tIns="45921" rIns="91842" bIns="45921" rtlCol="0" anchor="b"/>
          <a:lstStyle>
            <a:lvl1pPr algn="r">
              <a:defRPr sz="1300"/>
            </a:lvl1pPr>
          </a:lstStyle>
          <a:p>
            <a:fld id="{860CF95D-3A40-4878-B0EE-A6ACD39902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26766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1222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6875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4783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3605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529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9249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2253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5797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383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9430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de-DE"/>
              <a:t>17.07.2020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4752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/>
              <a:t>17.07.2020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fr-FR"/>
              <a:t>Figures &amp; Supplementals DKTK paper Version 4</a:t>
            </a: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6C7B3-8D75-491B-9EE9-21D99C50C2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5865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4220500"/>
              </p:ext>
            </p:extLst>
          </p:nvPr>
        </p:nvGraphicFramePr>
        <p:xfrm>
          <a:off x="1809000" y="776536"/>
          <a:ext cx="3311999" cy="4435200"/>
        </p:xfrm>
        <a:graphic>
          <a:graphicData uri="http://schemas.openxmlformats.org/drawingml/2006/table">
            <a:tbl>
              <a:tblPr/>
              <a:tblGrid>
                <a:gridCol w="233177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9149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8872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2016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e-related adverse event</a:t>
                      </a:r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11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E</a:t>
                      </a: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1600">
                <a:tc gridSpan="3"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E</a:t>
                      </a:r>
                      <a:r>
                        <a:rPr lang="de-DE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n(</a:t>
                      </a:r>
                      <a:r>
                        <a:rPr lang="de-DE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E</a:t>
                      </a:r>
                      <a:r>
                        <a:rPr lang="de-DE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10800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46491490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</a:txBody>
                  <a:tcPr marL="234000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itis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neumonitis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yroiditis</a:t>
                      </a:r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patitis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physitis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</a:t>
                      </a:r>
                      <a:r>
                        <a:rPr lang="de-DE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de-DE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titis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tis</a:t>
                      </a:r>
                      <a:endParaRPr lang="de-DE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01600">
                <a:tc gridSpan="3">
                  <a:txBody>
                    <a:bodyPr/>
                    <a:lstStyle/>
                    <a:p>
                      <a:pPr algn="l" rtl="0" fontAlgn="b"/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E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er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ckpoint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s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n(</a:t>
                      </a:r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s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</a:txBody>
                  <a:tcPr marL="2340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ilim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ilimumab/Nivol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mbroliz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vol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01600"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E-related</a:t>
                      </a:r>
                      <a:r>
                        <a:rPr lang="de-DE" sz="11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i="1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US" sz="1100" b="0" i="1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continuation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i="1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apy, n(patients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</a:txBody>
                  <a:tcPr marL="2340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84326169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ilim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ilimumab/Nivol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mbroliz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01600"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volumab </a:t>
                      </a:r>
                    </a:p>
                  </a:txBody>
                  <a:tcPr marL="392400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</a:tbl>
          </a:graphicData>
        </a:graphic>
      </p:graphicFrame>
      <p:sp>
        <p:nvSpPr>
          <p:cNvPr id="5" name="Rechteck 4">
            <a:extLst>
              <a:ext uri="{FF2B5EF4-FFF2-40B4-BE49-F238E27FC236}">
                <a16:creationId xmlns:a16="http://schemas.microsoft.com/office/drawing/2014/main" xmlns="" id="{8EBFBD2A-183A-4D46-8F64-A9E5207242F8}"/>
              </a:ext>
            </a:extLst>
          </p:cNvPr>
          <p:cNvSpPr/>
          <p:nvPr/>
        </p:nvSpPr>
        <p:spPr>
          <a:xfrm>
            <a:off x="332656" y="272480"/>
            <a:ext cx="172819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287875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</Words>
  <Application>Microsoft Office PowerPoint</Application>
  <PresentationFormat>A4-Papier (210x297 mm)</PresentationFormat>
  <Paragraphs>6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medizin Main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&amp; Tables DKTK paper</dc:title>
  <dc:creator>Krebs, Franziska</dc:creator>
  <cp:lastModifiedBy>Krebs, Franziska</cp:lastModifiedBy>
  <cp:revision>369</cp:revision>
  <cp:lastPrinted>2020-06-26T09:03:31Z</cp:lastPrinted>
  <dcterms:created xsi:type="dcterms:W3CDTF">2020-05-06T13:22:37Z</dcterms:created>
  <dcterms:modified xsi:type="dcterms:W3CDTF">2020-11-19T09:05:07Z</dcterms:modified>
</cp:coreProperties>
</file>